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6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PTGS2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3nt1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3nt1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34" y="142853"/>
            <a:ext cx="3286148" cy="28575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142852"/>
            <a:ext cx="3643338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143249"/>
            <a:ext cx="3286147" cy="28575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14686"/>
            <a:ext cx="3643338" cy="277812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0</cp:revision>
  <dcterms:created xsi:type="dcterms:W3CDTF">2018-05-10T07:33:24Z</dcterms:created>
  <dcterms:modified xsi:type="dcterms:W3CDTF">2018-05-29T07:40:48Z</dcterms:modified>
</cp:coreProperties>
</file>